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1594" r:id="rId2"/>
    <p:sldId id="1601" r:id="rId3"/>
    <p:sldId id="1602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42"/>
    <p:restoredTop sz="96301"/>
  </p:normalViewPr>
  <p:slideViewPr>
    <p:cSldViewPr snapToGrid="0" showGuides="1">
      <p:cViewPr varScale="1">
        <p:scale>
          <a:sx n="83" d="100"/>
          <a:sy n="83" d="100"/>
        </p:scale>
        <p:origin x="480" y="48"/>
      </p:cViewPr>
      <p:guideLst>
        <p:guide orient="horz" pos="2160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5E7F4D-EA5D-E047-B1F7-A3CF9175D10C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561E29-FCA0-0846-8DCF-41D606EE3D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83954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E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91DFA49-6700-42D0-B9C8-434ED786FC4B}" type="slidenum">
              <a:rPr lang="es-ES" smtClean="0"/>
              <a:pPr/>
              <a:t>1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980115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E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91DFA49-6700-42D0-B9C8-434ED786FC4B}" type="slidenum">
              <a:rPr lang="es-ES" smtClean="0"/>
              <a:pPr/>
              <a:t>2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0798321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E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91DFA49-6700-42D0-B9C8-434ED786FC4B}" type="slidenum">
              <a:rPr lang="es-ES" smtClean="0"/>
              <a:pPr/>
              <a:t>3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715837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8ADA713-1535-1ACB-CBB3-C6AB1A1F53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0B740B4-E56C-A0ED-9224-14438C52CE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MX"/>
              <a:t>Haz clic para editar el estilo de subtítulo del patrón</a:t>
            </a:r>
            <a:endParaRPr lang="es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EB05111-BD49-AC3E-896D-EB7162B2E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06B8249-5DEA-A426-F346-3CB33E7EA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BE6EB86-26C2-5362-880E-75E538F77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7946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D14586D-46BE-18FD-362A-8401842766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BE6BC26-B726-9F62-4B22-25FE37A0FC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60A3C1B-9E11-07FC-96DD-70E7F151BC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E80A632-1357-4BE8-DA23-C3B49A356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CE12600-FDD3-4A1D-C69D-D35699571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15310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D113097-4C29-C139-DD54-2F071DD054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59937C5-0E32-0F93-0AEE-6B932E6584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8EB38DD-1184-0080-F058-8B80EA6E9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5AC71DD-A1C7-7F23-F23A-75523F988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2B1526E-62C5-D205-ACF4-030EDE60E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3801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B838E6-D311-8BBE-4301-299520DE9C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CA5F489-4E74-F1EC-CA0A-F1ADE6CDD1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872AAE7-676F-C036-D18D-6183F8669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9700725-B08E-F837-42F1-50485EDF2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8517689-CEA8-8B35-89DC-9A5589E69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6462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C07E365-9393-83BD-1965-1B80F67FF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59B39C3-1684-6983-DCC6-C8D3111220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B723FF-4902-A7E9-A5C6-8EE7CD013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6D22039-EFDC-4CA8-9768-D7F683F05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F0F1D0B-270F-735E-C318-D86E5BB8A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9065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EA073B6-6263-B9CB-D166-0A3A38A367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27CEF98-7C1F-D136-61CC-B735F916C3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A684E1E-4B37-8312-122C-4208440F25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891C2F5-75D1-7185-FB23-E11A8C278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3CA4103-87B1-07CD-32BC-57FB1CA9E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212E5B7-A391-AB66-5437-B6727BE0A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4107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4715B3F-C025-66D0-CB7A-A198380364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E56DB90-1C3F-FF1E-F540-48DE243B63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2606970-1FBD-0CA4-24CA-B523273735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4BF0BC65-706E-0FB4-8AB4-1E08BC9DF2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B4A9E70-AA6F-A53E-E9EF-DB30225039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6DD226D-7EBC-89EB-8F07-A753B9A8F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8B0222B-7C2E-1D6C-B337-80AE20949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A694598-2480-6F56-8B82-B60039155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1104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253FD50-0BE1-78DF-4888-40B570680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F01DAE4-D9AD-AE41-537E-9B759FB943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C37EA9FC-54FB-F4D4-2FE9-231EA53BA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B5E257F-FF97-7F2E-9A01-DA03F40F6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56427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EB89D0D-CA99-453F-3674-769B29AA1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101B7AC3-2A1E-916A-6484-0037CE559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9FD5173D-00C3-2CDA-6ABF-BEAC56FC4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8476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40AA78-9243-1A9E-43FD-63D7E54B9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37E9C97-1711-C5CA-244D-A7DBD3A2BE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1A62CF2-C6BB-2BF0-FE92-A29A16C713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9E153B7-F042-5BBE-96A1-74E3D2122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C5F67B0-14E2-FBC2-C9FE-FDE7159DC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080B135-A8B6-CFF0-6FFF-33E8B8CBE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6884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A8D17EA-41E1-FABD-BCC5-AC26B18F0C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6F02FCA-1440-47D6-ABE5-61458B5C45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88266E5-5FAD-7AE8-B39F-E28FFC4D9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EBF66ED-5F05-8442-FA92-2CF518D14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8B6D8EF-55FF-3254-D42B-7CAA5E115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F776F47-CE5B-0441-12BE-1F845F205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5920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99124795-7548-5740-4F4F-B492681D3C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  <a:endParaRPr lang="es-E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23D0059-4941-10FA-860F-EB50507DCB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CB78B52-9564-7D90-C0EF-1A8BFACAA7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2F1909-750F-294B-847C-D4B85FF8E727}" type="datetimeFigureOut">
              <a:rPr lang="es-ES" smtClean="0"/>
              <a:t>30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9FF899B-B304-E86B-1A17-1C28AF7AF8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4823265-3460-07F5-9A85-C08C1B1F58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2BAE1-1754-F84F-9A5E-2C52FB7F586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9847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7E328336-37BE-1575-5F49-CB09A5E61B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967137"/>
            <a:ext cx="12192000" cy="2910236"/>
          </a:xfrm>
          <a:prstGeom prst="rect">
            <a:avLst/>
          </a:prstGeom>
        </p:spPr>
      </p:pic>
      <p:sp>
        <p:nvSpPr>
          <p:cNvPr id="2" name="Rectángulo 1">
            <a:extLst>
              <a:ext uri="{FF2B5EF4-FFF2-40B4-BE49-F238E27FC236}">
                <a16:creationId xmlns:a16="http://schemas.microsoft.com/office/drawing/2014/main" id="{CC4316EF-7B32-9414-AF4D-E792CF8D17A6}"/>
              </a:ext>
            </a:extLst>
          </p:cNvPr>
          <p:cNvSpPr/>
          <p:nvPr/>
        </p:nvSpPr>
        <p:spPr>
          <a:xfrm>
            <a:off x="4701535" y="6500701"/>
            <a:ext cx="2715905" cy="4003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Supplementary Figure S2</a:t>
            </a: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145BB632-41C9-8D51-EBF7-87982E8C201E}"/>
              </a:ext>
            </a:extLst>
          </p:cNvPr>
          <p:cNvSpPr/>
          <p:nvPr/>
        </p:nvSpPr>
        <p:spPr>
          <a:xfrm>
            <a:off x="4346089" y="1121296"/>
            <a:ext cx="3679115" cy="50310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8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0-months OS</a:t>
            </a:r>
            <a:r>
              <a:rPr lang="es-ES" b="1" dirty="0">
                <a:effectLst/>
              </a:rPr>
              <a:t> </a:t>
            </a:r>
            <a:endParaRPr lang="es-ES" b="1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632627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543B21E6-2FD2-E951-B36D-E6FF6664CD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26214"/>
            <a:ext cx="12192000" cy="3307298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FCD4B536-D9A7-1DB9-E695-E32F74ED2780}"/>
              </a:ext>
            </a:extLst>
          </p:cNvPr>
          <p:cNvSpPr/>
          <p:nvPr/>
        </p:nvSpPr>
        <p:spPr>
          <a:xfrm>
            <a:off x="4701535" y="6500701"/>
            <a:ext cx="2715905" cy="4003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Supplementary Figure S3</a:t>
            </a: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10729AA9-4641-D748-2E09-1A8D1C12C7D9}"/>
              </a:ext>
            </a:extLst>
          </p:cNvPr>
          <p:cNvSpPr/>
          <p:nvPr/>
        </p:nvSpPr>
        <p:spPr>
          <a:xfrm>
            <a:off x="103992" y="178674"/>
            <a:ext cx="290455" cy="29614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ysClr val="windowText" lastClr="000000"/>
                </a:solidFill>
              </a:rPr>
              <a:t>A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2FB6C392-0100-C444-41A9-C0E88333B0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58" y="3149304"/>
            <a:ext cx="12213706" cy="3313187"/>
          </a:xfrm>
          <a:prstGeom prst="rect">
            <a:avLst/>
          </a:prstGeom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7A54D9B9-8291-C3EB-3FC1-BFE5FE00411E}"/>
              </a:ext>
            </a:extLst>
          </p:cNvPr>
          <p:cNvSpPr/>
          <p:nvPr/>
        </p:nvSpPr>
        <p:spPr>
          <a:xfrm>
            <a:off x="104007" y="3545821"/>
            <a:ext cx="290455" cy="29614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ysClr val="windowText" lastClr="000000"/>
                </a:solidFill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102269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ángulo 9">
            <a:extLst>
              <a:ext uri="{FF2B5EF4-FFF2-40B4-BE49-F238E27FC236}">
                <a16:creationId xmlns:a16="http://schemas.microsoft.com/office/drawing/2014/main" id="{10729AA9-4641-D748-2E09-1A8D1C12C7D9}"/>
              </a:ext>
            </a:extLst>
          </p:cNvPr>
          <p:cNvSpPr/>
          <p:nvPr/>
        </p:nvSpPr>
        <p:spPr>
          <a:xfrm>
            <a:off x="103992" y="178674"/>
            <a:ext cx="290455" cy="29614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ysClr val="windowText" lastClr="000000"/>
                </a:solidFill>
              </a:rPr>
              <a:t>A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7A54D9B9-8291-C3EB-3FC1-BFE5FE00411E}"/>
              </a:ext>
            </a:extLst>
          </p:cNvPr>
          <p:cNvSpPr/>
          <p:nvPr/>
        </p:nvSpPr>
        <p:spPr>
          <a:xfrm>
            <a:off x="6096000" y="157158"/>
            <a:ext cx="290455" cy="29614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ysClr val="windowText" lastClr="000000"/>
                </a:solidFill>
              </a:rPr>
              <a:t>B</a:t>
            </a:r>
          </a:p>
        </p:txBody>
      </p:sp>
      <p:sp>
        <p:nvSpPr>
          <p:cNvPr id="2" name="Rectángulo 1">
            <a:extLst>
              <a:ext uri="{FF2B5EF4-FFF2-40B4-BE49-F238E27FC236}">
                <a16:creationId xmlns:a16="http://schemas.microsoft.com/office/drawing/2014/main" id="{ACF28F1C-63E1-AC71-E3AE-2A3208786DC4}"/>
              </a:ext>
            </a:extLst>
          </p:cNvPr>
          <p:cNvSpPr/>
          <p:nvPr/>
        </p:nvSpPr>
        <p:spPr>
          <a:xfrm>
            <a:off x="103992" y="3558368"/>
            <a:ext cx="290455" cy="29614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ysClr val="windowText" lastClr="000000"/>
                </a:solidFill>
              </a:rPr>
              <a:t>C</a:t>
            </a: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3C65C7BE-80F9-523A-B8F8-AA07DD2475DB}"/>
              </a:ext>
            </a:extLst>
          </p:cNvPr>
          <p:cNvSpPr/>
          <p:nvPr/>
        </p:nvSpPr>
        <p:spPr>
          <a:xfrm>
            <a:off x="6096000" y="3536852"/>
            <a:ext cx="290455" cy="29614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ysClr val="windowText" lastClr="000000"/>
                </a:solidFill>
              </a:rPr>
              <a:t>D</a:t>
            </a:r>
          </a:p>
        </p:txBody>
      </p:sp>
      <p:pic>
        <p:nvPicPr>
          <p:cNvPr id="9" name="Imagen 8">
            <a:extLst>
              <a:ext uri="{FF2B5EF4-FFF2-40B4-BE49-F238E27FC236}">
                <a16:creationId xmlns:a16="http://schemas.microsoft.com/office/drawing/2014/main" id="{D7385484-94BE-E26B-8F5E-C8E7C3A1B3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3754" y="128706"/>
            <a:ext cx="4776626" cy="3180670"/>
          </a:xfrm>
          <a:prstGeom prst="rect">
            <a:avLst/>
          </a:prstGeom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9D115915-6242-8A51-6D2F-B8DDDF8397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9924" y="128706"/>
            <a:ext cx="4776626" cy="3180670"/>
          </a:xfrm>
          <a:prstGeom prst="rect">
            <a:avLst/>
          </a:prstGeom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55B7E53D-063A-6533-43EE-CC9CF77044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89037" y="3576513"/>
            <a:ext cx="4776625" cy="3180670"/>
          </a:xfrm>
          <a:prstGeom prst="rect">
            <a:avLst/>
          </a:prstGeom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D5FB450B-6B14-236E-5ADB-2CFCACB2522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1439" y="3549636"/>
            <a:ext cx="4776626" cy="3180670"/>
          </a:xfrm>
          <a:prstGeom prst="rect">
            <a:avLst/>
          </a:prstGeom>
        </p:spPr>
      </p:pic>
      <p:sp>
        <p:nvSpPr>
          <p:cNvPr id="18" name="Rectángulo 17">
            <a:extLst>
              <a:ext uri="{FF2B5EF4-FFF2-40B4-BE49-F238E27FC236}">
                <a16:creationId xmlns:a16="http://schemas.microsoft.com/office/drawing/2014/main" id="{04716694-38F5-DEDC-2FC9-C3DB6C979706}"/>
              </a:ext>
            </a:extLst>
          </p:cNvPr>
          <p:cNvSpPr/>
          <p:nvPr/>
        </p:nvSpPr>
        <p:spPr>
          <a:xfrm>
            <a:off x="4701535" y="6500701"/>
            <a:ext cx="2715905" cy="4003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</a:rPr>
              <a:t>Supplementary</a:t>
            </a:r>
            <a:r>
              <a:rPr lang="en-US" sz="1400" b="1" dirty="0">
                <a:solidFill>
                  <a:schemeClr val="tx1"/>
                </a:solidFill>
              </a:rPr>
              <a:t> </a:t>
            </a:r>
            <a:r>
              <a:rPr lang="en-US" sz="1200" b="1" dirty="0">
                <a:solidFill>
                  <a:schemeClr val="tx1"/>
                </a:solidFill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10062195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66</TotalTime>
  <Words>23</Words>
  <Application>Microsoft Office PowerPoint</Application>
  <PresentationFormat>Widescreen</PresentationFormat>
  <Paragraphs>16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O, EZEQUIEL MATIAS (ICMDM)</dc:creator>
  <cp:lastModifiedBy>MDPI</cp:lastModifiedBy>
  <cp:revision>34</cp:revision>
  <dcterms:created xsi:type="dcterms:W3CDTF">2023-07-16T16:33:02Z</dcterms:created>
  <dcterms:modified xsi:type="dcterms:W3CDTF">2024-05-30T09:54:18Z</dcterms:modified>
</cp:coreProperties>
</file>